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60" r:id="rId4"/>
    <p:sldId id="261" r:id="rId5"/>
    <p:sldId id="262" r:id="rId6"/>
    <p:sldId id="263" r:id="rId7"/>
    <p:sldId id="265" r:id="rId8"/>
    <p:sldId id="266" r:id="rId9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420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837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1674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930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885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822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244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40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448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307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894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038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4471" t="60738" r="66829" b="27527"/>
          <a:stretch/>
        </p:blipFill>
        <p:spPr>
          <a:xfrm>
            <a:off x="1360447" y="791735"/>
            <a:ext cx="2497875" cy="102087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27717" y="122663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307457-02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l="26179" t="24283" r="42277" b="55493"/>
          <a:stretch/>
        </p:blipFill>
        <p:spPr>
          <a:xfrm flipH="1">
            <a:off x="4045158" y="815097"/>
            <a:ext cx="2322188" cy="969572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242050" y="133815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384187-01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7841" y="4899318"/>
            <a:ext cx="2525791" cy="1883265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94735" y="4877015"/>
            <a:ext cx="2538452" cy="187377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6"/>
          <a:srcRect l="25958" t="25260" r="42498" b="55264"/>
          <a:stretch/>
        </p:blipFill>
        <p:spPr>
          <a:xfrm flipH="1">
            <a:off x="2435174" y="2721461"/>
            <a:ext cx="2114523" cy="850171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2427854" y="2000365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120906-02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30802" y="7263700"/>
            <a:ext cx="2534455" cy="18803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598083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720791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836235" y="186968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0" y="460173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3631581" y="460173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802780" y="688773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B9FB5A4-09CC-4D48-BDFE-D6B84B28A639}"/>
              </a:ext>
            </a:extLst>
          </p:cNvPr>
          <p:cNvSpPr txBox="1"/>
          <p:nvPr/>
        </p:nvSpPr>
        <p:spPr>
          <a:xfrm>
            <a:off x="-105819" y="315648"/>
            <a:ext cx="162576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 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mpound (µM)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WRN (1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3FAF9105-16D7-4DF7-BC49-1FE05F332334}"/>
              </a:ext>
            </a:extLst>
          </p:cNvPr>
          <p:cNvSpPr/>
          <p:nvPr/>
        </p:nvSpPr>
        <p:spPr>
          <a:xfrm>
            <a:off x="1376693" y="585107"/>
            <a:ext cx="222515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   +   +  +  +   +   +  +   +  +  + </a:t>
            </a:r>
          </a:p>
        </p:txBody>
      </p:sp>
      <p:sp>
        <p:nvSpPr>
          <p:cNvPr id="21" name="Isosceles Triangle 20">
            <a:extLst>
              <a:ext uri="{FF2B5EF4-FFF2-40B4-BE49-F238E27FC236}">
                <a16:creationId xmlns:a16="http://schemas.microsoft.com/office/drawing/2014/main" id="{F5DE04E1-BF4A-402A-A70E-A41E2B80A166}"/>
              </a:ext>
            </a:extLst>
          </p:cNvPr>
          <p:cNvSpPr/>
          <p:nvPr/>
        </p:nvSpPr>
        <p:spPr>
          <a:xfrm>
            <a:off x="3554691" y="541913"/>
            <a:ext cx="136362" cy="18291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86D1FAB-227A-46EF-B7F1-33DD3EB49489}"/>
              </a:ext>
            </a:extLst>
          </p:cNvPr>
          <p:cNvSpPr txBox="1"/>
          <p:nvPr/>
        </p:nvSpPr>
        <p:spPr>
          <a:xfrm>
            <a:off x="1456765" y="371405"/>
            <a:ext cx="20762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.05 0.1 0.5 1   5   10  50 100 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31F77AB-4111-46F6-A0D8-D33BA6120DAD}"/>
              </a:ext>
            </a:extLst>
          </p:cNvPr>
          <p:cNvSpPr/>
          <p:nvPr/>
        </p:nvSpPr>
        <p:spPr>
          <a:xfrm>
            <a:off x="1389930" y="421829"/>
            <a:ext cx="41710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   -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A515197A-32CF-4277-A018-D7AF23DDF42C}"/>
              </a:ext>
            </a:extLst>
          </p:cNvPr>
          <p:cNvSpPr/>
          <p:nvPr/>
        </p:nvSpPr>
        <p:spPr>
          <a:xfrm>
            <a:off x="3326525" y="395809"/>
            <a:ext cx="3658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  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D286FEA2-A4AB-41E8-B103-7873C7DBF260}"/>
              </a:ext>
            </a:extLst>
          </p:cNvPr>
          <p:cNvSpPr/>
          <p:nvPr/>
        </p:nvSpPr>
        <p:spPr>
          <a:xfrm>
            <a:off x="4138479" y="581390"/>
            <a:ext cx="217311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   +   +   +   +  +   +   +    +</a:t>
            </a:r>
          </a:p>
        </p:txBody>
      </p:sp>
      <p:sp>
        <p:nvSpPr>
          <p:cNvPr id="28" name="Isosceles Triangle 27">
            <a:extLst>
              <a:ext uri="{FF2B5EF4-FFF2-40B4-BE49-F238E27FC236}">
                <a16:creationId xmlns:a16="http://schemas.microsoft.com/office/drawing/2014/main" id="{95E5F2A5-00B2-45EA-8149-18A2A749924A}"/>
              </a:ext>
            </a:extLst>
          </p:cNvPr>
          <p:cNvSpPr/>
          <p:nvPr/>
        </p:nvSpPr>
        <p:spPr>
          <a:xfrm>
            <a:off x="6071149" y="549348"/>
            <a:ext cx="136362" cy="18291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E071F2F-A58B-45B5-9CD5-D166F5F29197}"/>
              </a:ext>
            </a:extLst>
          </p:cNvPr>
          <p:cNvSpPr txBox="1"/>
          <p:nvPr/>
        </p:nvSpPr>
        <p:spPr>
          <a:xfrm>
            <a:off x="4218550" y="367688"/>
            <a:ext cx="19848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0.1 0.5  1    5   10  50  100 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1E932F73-8098-45F1-9231-AFDA83508307}"/>
              </a:ext>
            </a:extLst>
          </p:cNvPr>
          <p:cNvSpPr/>
          <p:nvPr/>
        </p:nvSpPr>
        <p:spPr>
          <a:xfrm>
            <a:off x="4151715" y="418112"/>
            <a:ext cx="41710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   -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1B66169F-FDD5-437C-A154-8EC394B6D0BA}"/>
              </a:ext>
            </a:extLst>
          </p:cNvPr>
          <p:cNvSpPr/>
          <p:nvPr/>
        </p:nvSpPr>
        <p:spPr>
          <a:xfrm>
            <a:off x="2465796" y="2499400"/>
            <a:ext cx="19277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   +  +   +  +   +   +  +   +  </a:t>
            </a:r>
          </a:p>
        </p:txBody>
      </p:sp>
      <p:sp>
        <p:nvSpPr>
          <p:cNvPr id="32" name="Isosceles Triangle 31">
            <a:extLst>
              <a:ext uri="{FF2B5EF4-FFF2-40B4-BE49-F238E27FC236}">
                <a16:creationId xmlns:a16="http://schemas.microsoft.com/office/drawing/2014/main" id="{56D167C8-DD4F-481B-96AA-035E9E963F12}"/>
              </a:ext>
            </a:extLst>
          </p:cNvPr>
          <p:cNvSpPr/>
          <p:nvPr/>
        </p:nvSpPr>
        <p:spPr>
          <a:xfrm>
            <a:off x="4275803" y="2478508"/>
            <a:ext cx="136362" cy="18291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C79698B-81B3-4A5B-998D-4FA1CE381CA9}"/>
              </a:ext>
            </a:extLst>
          </p:cNvPr>
          <p:cNvSpPr txBox="1"/>
          <p:nvPr/>
        </p:nvSpPr>
        <p:spPr>
          <a:xfrm>
            <a:off x="2545868" y="2285698"/>
            <a:ext cx="18998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0.1 0.5  1    5  10  50 100 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A35AF7AF-DCFF-4DFD-B225-095792129909}"/>
              </a:ext>
            </a:extLst>
          </p:cNvPr>
          <p:cNvSpPr/>
          <p:nvPr/>
        </p:nvSpPr>
        <p:spPr>
          <a:xfrm>
            <a:off x="2479033" y="2336122"/>
            <a:ext cx="41710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   -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28D4BC1-D54D-44FC-8C68-FFB2DCE45D78}"/>
              </a:ext>
            </a:extLst>
          </p:cNvPr>
          <p:cNvSpPr txBox="1"/>
          <p:nvPr/>
        </p:nvSpPr>
        <p:spPr>
          <a:xfrm>
            <a:off x="927527" y="2229941"/>
            <a:ext cx="162576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  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mpound (µM)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            WRN (1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40706348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2798" t="24107" r="40877" b="55169"/>
          <a:stretch/>
        </p:blipFill>
        <p:spPr>
          <a:xfrm>
            <a:off x="1873997" y="1532742"/>
            <a:ext cx="4421787" cy="128819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17566" y="940117"/>
            <a:ext cx="18678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  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mpound (µM)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         WRN (1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" name="Rectangle 3"/>
          <p:cNvSpPr/>
          <p:nvPr/>
        </p:nvSpPr>
        <p:spPr>
          <a:xfrm>
            <a:off x="1967708" y="1209575"/>
            <a:ext cx="408690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 + + +</a:t>
            </a:r>
          </a:p>
        </p:txBody>
      </p:sp>
      <p:sp>
        <p:nvSpPr>
          <p:cNvPr id="5" name="Isosceles Triangle 4"/>
          <p:cNvSpPr/>
          <p:nvPr/>
        </p:nvSpPr>
        <p:spPr>
          <a:xfrm>
            <a:off x="5851843" y="1132925"/>
            <a:ext cx="271804" cy="32197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2326560" y="940117"/>
            <a:ext cx="37625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1    5  10  25 50 100  1   5  10  25  50 10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521178" y="528056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CGC00029283-0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207844" y="528055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CGC00063279-02</a:t>
            </a:r>
          </a:p>
        </p:txBody>
      </p:sp>
      <p:sp>
        <p:nvSpPr>
          <p:cNvPr id="9" name="Rectangle 8"/>
          <p:cNvSpPr/>
          <p:nvPr/>
        </p:nvSpPr>
        <p:spPr>
          <a:xfrm>
            <a:off x="1958642" y="890180"/>
            <a:ext cx="5982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- -</a:t>
            </a:r>
            <a:endParaRPr lang="en-US" dirty="0"/>
          </a:p>
        </p:txBody>
      </p:sp>
      <p:sp>
        <p:nvSpPr>
          <p:cNvPr id="10" name="Left Brace 9"/>
          <p:cNvSpPr/>
          <p:nvPr/>
        </p:nvSpPr>
        <p:spPr>
          <a:xfrm rot="5400000">
            <a:off x="3325709" y="137289"/>
            <a:ext cx="153440" cy="1610830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Left Brace 10"/>
          <p:cNvSpPr/>
          <p:nvPr/>
        </p:nvSpPr>
        <p:spPr>
          <a:xfrm rot="5400000">
            <a:off x="4967046" y="134701"/>
            <a:ext cx="153440" cy="1610830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58458" y="3414198"/>
            <a:ext cx="4505399" cy="3333995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156117" y="457200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98083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483112" y="316694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6629858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9512" t="14295" r="66667" b="76217"/>
          <a:stretch/>
        </p:blipFill>
        <p:spPr>
          <a:xfrm>
            <a:off x="1493262" y="1587874"/>
            <a:ext cx="2568753" cy="114838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9350" t="61239" r="68455" b="29272"/>
          <a:stretch/>
        </p:blipFill>
        <p:spPr>
          <a:xfrm flipH="1">
            <a:off x="4193742" y="1567756"/>
            <a:ext cx="2306256" cy="116850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-247813" y="928966"/>
            <a:ext cx="18678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  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mpound (µM)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         WRN (1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" name="Rectangle 4"/>
          <p:cNvSpPr/>
          <p:nvPr/>
        </p:nvSpPr>
        <p:spPr>
          <a:xfrm>
            <a:off x="1502329" y="1198424"/>
            <a:ext cx="484271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  + + + + + + +</a:t>
            </a:r>
          </a:p>
        </p:txBody>
      </p:sp>
      <p:sp>
        <p:nvSpPr>
          <p:cNvPr id="6" name="Isosceles Triangle 5"/>
          <p:cNvSpPr/>
          <p:nvPr/>
        </p:nvSpPr>
        <p:spPr>
          <a:xfrm>
            <a:off x="6183551" y="1081564"/>
            <a:ext cx="271804" cy="32197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1861181" y="928966"/>
            <a:ext cx="45079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1.3 2.5  5  10  25 50 100     1.3 2.5  5  10  25 50 10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157325" y="516903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CGC00183602-0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360125" y="516718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CGC00295201-02</a:t>
            </a:r>
          </a:p>
        </p:txBody>
      </p:sp>
      <p:sp>
        <p:nvSpPr>
          <p:cNvPr id="10" name="Rectangle 9"/>
          <p:cNvSpPr/>
          <p:nvPr/>
        </p:nvSpPr>
        <p:spPr>
          <a:xfrm>
            <a:off x="1493263" y="879029"/>
            <a:ext cx="5982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- -</a:t>
            </a:r>
            <a:endParaRPr lang="en-US" dirty="0"/>
          </a:p>
        </p:txBody>
      </p:sp>
      <p:sp>
        <p:nvSpPr>
          <p:cNvPr id="11" name="Left Brace 10"/>
          <p:cNvSpPr/>
          <p:nvPr/>
        </p:nvSpPr>
        <p:spPr>
          <a:xfrm rot="5400000">
            <a:off x="2973193" y="-57195"/>
            <a:ext cx="207130" cy="1970512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Brace 11"/>
          <p:cNvSpPr/>
          <p:nvPr/>
        </p:nvSpPr>
        <p:spPr>
          <a:xfrm rot="5400000">
            <a:off x="5137872" y="-50472"/>
            <a:ext cx="155782" cy="1946324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8123" y="3067272"/>
            <a:ext cx="4871126" cy="3615241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00361" y="189570"/>
            <a:ext cx="245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I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237786" y="291046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98083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</a:p>
        </p:txBody>
      </p:sp>
    </p:spTree>
    <p:extLst>
      <p:ext uri="{BB962C8B-B14F-4D97-AF65-F5344CB8AC3E}">
        <p14:creationId xmlns:p14="http://schemas.microsoft.com/office/powerpoint/2010/main" val="5519759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8861" t="13296" r="67480" b="77966"/>
          <a:stretch/>
        </p:blipFill>
        <p:spPr>
          <a:xfrm flipH="1">
            <a:off x="1417363" y="1513545"/>
            <a:ext cx="2539701" cy="105820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9437" t="61333" r="66179" b="29928"/>
          <a:stretch/>
        </p:blipFill>
        <p:spPr>
          <a:xfrm>
            <a:off x="4114799" y="1513545"/>
            <a:ext cx="2674553" cy="105820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-324013" y="928966"/>
            <a:ext cx="18678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  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mpound (µM)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         WRN (1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" name="Rectangle 4"/>
          <p:cNvSpPr/>
          <p:nvPr/>
        </p:nvSpPr>
        <p:spPr>
          <a:xfrm>
            <a:off x="1426129" y="1198424"/>
            <a:ext cx="484271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  + + + + + + +</a:t>
            </a:r>
          </a:p>
        </p:txBody>
      </p:sp>
      <p:sp>
        <p:nvSpPr>
          <p:cNvPr id="6" name="Isosceles Triangle 5"/>
          <p:cNvSpPr/>
          <p:nvPr/>
        </p:nvSpPr>
        <p:spPr>
          <a:xfrm>
            <a:off x="6107351" y="1081564"/>
            <a:ext cx="271804" cy="32197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1784981" y="928966"/>
            <a:ext cx="44582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0.5 1   5  10  25 50 100      0.5  1   5  10  25  50 10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081125" y="516903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CGC00132363-04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283925" y="516718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CGC00128735-02</a:t>
            </a:r>
          </a:p>
        </p:txBody>
      </p:sp>
      <p:sp>
        <p:nvSpPr>
          <p:cNvPr id="10" name="Rectangle 9"/>
          <p:cNvSpPr/>
          <p:nvPr/>
        </p:nvSpPr>
        <p:spPr>
          <a:xfrm>
            <a:off x="1417063" y="879029"/>
            <a:ext cx="5982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- -</a:t>
            </a:r>
            <a:endParaRPr lang="en-US" dirty="0"/>
          </a:p>
        </p:txBody>
      </p:sp>
      <p:sp>
        <p:nvSpPr>
          <p:cNvPr id="11" name="Left Brace 10"/>
          <p:cNvSpPr/>
          <p:nvPr/>
        </p:nvSpPr>
        <p:spPr>
          <a:xfrm rot="5400000">
            <a:off x="2889033" y="2336"/>
            <a:ext cx="198732" cy="1843051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Brace 11"/>
          <p:cNvSpPr/>
          <p:nvPr/>
        </p:nvSpPr>
        <p:spPr>
          <a:xfrm rot="5400000">
            <a:off x="5061672" y="-50472"/>
            <a:ext cx="155782" cy="1946324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26129" y="3123281"/>
            <a:ext cx="4877223" cy="3621338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89571" y="33453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115122" y="293277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98083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</a:p>
        </p:txBody>
      </p:sp>
    </p:spTree>
    <p:extLst>
      <p:ext uri="{BB962C8B-B14F-4D97-AF65-F5344CB8AC3E}">
        <p14:creationId xmlns:p14="http://schemas.microsoft.com/office/powerpoint/2010/main" val="27055642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8333" t="13530" r="67083" b="76446"/>
          <a:stretch/>
        </p:blipFill>
        <p:spPr>
          <a:xfrm>
            <a:off x="1287244" y="1487163"/>
            <a:ext cx="2760882" cy="123582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8333" t="60238" r="68751" b="29952"/>
          <a:stretch/>
        </p:blipFill>
        <p:spPr>
          <a:xfrm>
            <a:off x="4048126" y="1535258"/>
            <a:ext cx="2438399" cy="120609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-324013" y="928966"/>
            <a:ext cx="18678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  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mpound (µM)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         WRN (1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" name="Rectangle 4"/>
          <p:cNvSpPr/>
          <p:nvPr/>
        </p:nvSpPr>
        <p:spPr>
          <a:xfrm>
            <a:off x="1426129" y="1198424"/>
            <a:ext cx="484271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  + + + + + + +</a:t>
            </a:r>
          </a:p>
        </p:txBody>
      </p:sp>
      <p:sp>
        <p:nvSpPr>
          <p:cNvPr id="6" name="Isosceles Triangle 5"/>
          <p:cNvSpPr/>
          <p:nvPr/>
        </p:nvSpPr>
        <p:spPr>
          <a:xfrm>
            <a:off x="6107351" y="1081564"/>
            <a:ext cx="271804" cy="32197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1784981" y="928966"/>
            <a:ext cx="44582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0.5 1   5  10  25 50 100      0.5  1   5  10  25  50 10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081125" y="516903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CGC00128865-0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283925" y="516718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CGC00129037-02</a:t>
            </a:r>
          </a:p>
        </p:txBody>
      </p:sp>
      <p:sp>
        <p:nvSpPr>
          <p:cNvPr id="10" name="Rectangle 9"/>
          <p:cNvSpPr/>
          <p:nvPr/>
        </p:nvSpPr>
        <p:spPr>
          <a:xfrm>
            <a:off x="1417063" y="879029"/>
            <a:ext cx="5982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- -</a:t>
            </a:r>
            <a:endParaRPr lang="en-US" dirty="0"/>
          </a:p>
        </p:txBody>
      </p:sp>
      <p:sp>
        <p:nvSpPr>
          <p:cNvPr id="11" name="Left Brace 10"/>
          <p:cNvSpPr/>
          <p:nvPr/>
        </p:nvSpPr>
        <p:spPr>
          <a:xfrm rot="5400000">
            <a:off x="2889033" y="2336"/>
            <a:ext cx="198732" cy="1843051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Brace 11"/>
          <p:cNvSpPr/>
          <p:nvPr/>
        </p:nvSpPr>
        <p:spPr>
          <a:xfrm rot="5400000">
            <a:off x="5061672" y="-50472"/>
            <a:ext cx="155782" cy="1946324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0128" y="3507329"/>
            <a:ext cx="4877223" cy="3615241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211874" y="156118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959005" y="325615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98083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</a:p>
        </p:txBody>
      </p:sp>
    </p:spTree>
    <p:extLst>
      <p:ext uri="{BB962C8B-B14F-4D97-AF65-F5344CB8AC3E}">
        <p14:creationId xmlns:p14="http://schemas.microsoft.com/office/powerpoint/2010/main" val="8399927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8889" t="13316" r="66667" b="75380"/>
          <a:stretch/>
        </p:blipFill>
        <p:spPr>
          <a:xfrm flipH="1">
            <a:off x="1315817" y="1403541"/>
            <a:ext cx="2722217" cy="1387284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9861" t="59598" r="66666" b="29739"/>
          <a:stretch/>
        </p:blipFill>
        <p:spPr>
          <a:xfrm flipH="1">
            <a:off x="3990408" y="1418006"/>
            <a:ext cx="2505641" cy="129156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-324013" y="928966"/>
            <a:ext cx="18678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  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mpound (µM)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         WRN (1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" name="Rectangle 4"/>
          <p:cNvSpPr/>
          <p:nvPr/>
        </p:nvSpPr>
        <p:spPr>
          <a:xfrm>
            <a:off x="1426129" y="1198424"/>
            <a:ext cx="484271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  + + + + + + +</a:t>
            </a:r>
          </a:p>
        </p:txBody>
      </p:sp>
      <p:sp>
        <p:nvSpPr>
          <p:cNvPr id="6" name="Isosceles Triangle 5"/>
          <p:cNvSpPr/>
          <p:nvPr/>
        </p:nvSpPr>
        <p:spPr>
          <a:xfrm>
            <a:off x="6107351" y="1081564"/>
            <a:ext cx="271804" cy="32197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1784981" y="928966"/>
            <a:ext cx="44582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0.5 1   5  10  25 50 100      0.5  1   5  10  25  50 10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081125" y="516903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NCGC00120928-0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283925" y="516718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LS002251300-02</a:t>
            </a:r>
          </a:p>
        </p:txBody>
      </p:sp>
      <p:sp>
        <p:nvSpPr>
          <p:cNvPr id="10" name="Rectangle 9"/>
          <p:cNvSpPr/>
          <p:nvPr/>
        </p:nvSpPr>
        <p:spPr>
          <a:xfrm>
            <a:off x="1417063" y="879029"/>
            <a:ext cx="5982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- -</a:t>
            </a:r>
            <a:endParaRPr lang="en-US" dirty="0"/>
          </a:p>
        </p:txBody>
      </p:sp>
      <p:sp>
        <p:nvSpPr>
          <p:cNvPr id="11" name="Left Brace 10"/>
          <p:cNvSpPr/>
          <p:nvPr/>
        </p:nvSpPr>
        <p:spPr>
          <a:xfrm rot="5400000">
            <a:off x="2889033" y="2336"/>
            <a:ext cx="198732" cy="1843051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Brace 11"/>
          <p:cNvSpPr/>
          <p:nvPr/>
        </p:nvSpPr>
        <p:spPr>
          <a:xfrm rot="5400000">
            <a:off x="5061672" y="-50472"/>
            <a:ext cx="155782" cy="1946324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9438" y="2890835"/>
            <a:ext cx="4877223" cy="3615241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334536" y="100361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58282" y="270974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98083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</a:p>
        </p:txBody>
      </p:sp>
    </p:spTree>
    <p:extLst>
      <p:ext uri="{BB962C8B-B14F-4D97-AF65-F5344CB8AC3E}">
        <p14:creationId xmlns:p14="http://schemas.microsoft.com/office/powerpoint/2010/main" val="35372182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18536" t="13546" r="67317" b="76716"/>
          <a:stretch/>
        </p:blipFill>
        <p:spPr>
          <a:xfrm flipH="1">
            <a:off x="1358431" y="1525359"/>
            <a:ext cx="2656007" cy="1190624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9675" t="61735" r="67317" b="29526"/>
          <a:stretch/>
        </p:blipFill>
        <p:spPr>
          <a:xfrm>
            <a:off x="4027299" y="1582750"/>
            <a:ext cx="2459066" cy="107584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-324013" y="928966"/>
            <a:ext cx="18678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  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mpound (µM)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         WRN (1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" name="Rectangle 4"/>
          <p:cNvSpPr/>
          <p:nvPr/>
        </p:nvSpPr>
        <p:spPr>
          <a:xfrm>
            <a:off x="1426129" y="1198424"/>
            <a:ext cx="506023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+ + + + + + + + -     + + + + + + +</a:t>
            </a:r>
          </a:p>
        </p:txBody>
      </p:sp>
      <p:sp>
        <p:nvSpPr>
          <p:cNvPr id="6" name="Isosceles Triangle 5"/>
          <p:cNvSpPr/>
          <p:nvPr/>
        </p:nvSpPr>
        <p:spPr>
          <a:xfrm>
            <a:off x="4206831" y="1092288"/>
            <a:ext cx="271804" cy="32197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1208608" y="940064"/>
            <a:ext cx="53030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0.5  1   5  10  25 50 100                       0.5  1   5  10  25  50 10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588410" y="506096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LS002608028-0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640761" y="516718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LS001160745-02</a:t>
            </a:r>
          </a:p>
        </p:txBody>
      </p:sp>
      <p:sp>
        <p:nvSpPr>
          <p:cNvPr id="10" name="Rectangle 9"/>
          <p:cNvSpPr/>
          <p:nvPr/>
        </p:nvSpPr>
        <p:spPr>
          <a:xfrm>
            <a:off x="3358006" y="909286"/>
            <a:ext cx="5982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- -</a:t>
            </a:r>
            <a:endParaRPr lang="en-US" dirty="0"/>
          </a:p>
        </p:txBody>
      </p:sp>
      <p:sp>
        <p:nvSpPr>
          <p:cNvPr id="11" name="Left Brace 10"/>
          <p:cNvSpPr/>
          <p:nvPr/>
        </p:nvSpPr>
        <p:spPr>
          <a:xfrm rot="5400000">
            <a:off x="2309170" y="2336"/>
            <a:ext cx="198732" cy="1843051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Brace 11"/>
          <p:cNvSpPr/>
          <p:nvPr/>
        </p:nvSpPr>
        <p:spPr>
          <a:xfrm rot="5400000">
            <a:off x="5396208" y="-50472"/>
            <a:ext cx="155782" cy="1946324"/>
          </a:xfrm>
          <a:prstGeom prst="leftBrac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9394" y="2962724"/>
            <a:ext cx="4877223" cy="3615241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156117" y="211874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46771" y="264283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98083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</a:p>
        </p:txBody>
      </p:sp>
    </p:spTree>
    <p:extLst>
      <p:ext uri="{BB962C8B-B14F-4D97-AF65-F5344CB8AC3E}">
        <p14:creationId xmlns:p14="http://schemas.microsoft.com/office/powerpoint/2010/main" val="29064390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23252" t="23533" r="42602" b="55743"/>
          <a:stretch/>
        </p:blipFill>
        <p:spPr>
          <a:xfrm>
            <a:off x="1431253" y="1524839"/>
            <a:ext cx="3073840" cy="1214898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-324013" y="928966"/>
            <a:ext cx="1867819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   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mpound (µM)</a:t>
            </a:r>
          </a:p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         WRN (1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8" name="Rectangle 17"/>
          <p:cNvSpPr/>
          <p:nvPr/>
        </p:nvSpPr>
        <p:spPr>
          <a:xfrm>
            <a:off x="1426129" y="1198424"/>
            <a:ext cx="484271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  </a:t>
            </a:r>
          </a:p>
        </p:txBody>
      </p:sp>
      <p:sp>
        <p:nvSpPr>
          <p:cNvPr id="19" name="Isosceles Triangle 18"/>
          <p:cNvSpPr/>
          <p:nvPr/>
        </p:nvSpPr>
        <p:spPr>
          <a:xfrm>
            <a:off x="4124717" y="1125691"/>
            <a:ext cx="271804" cy="32197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/>
          <p:cNvSpPr txBox="1"/>
          <p:nvPr/>
        </p:nvSpPr>
        <p:spPr>
          <a:xfrm>
            <a:off x="1784981" y="928966"/>
            <a:ext cx="25202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   0.5 1   5  10  25 50 100      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081125" y="516903"/>
            <a:ext cx="1828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LS001139594-03</a:t>
            </a:r>
          </a:p>
        </p:txBody>
      </p:sp>
      <p:sp>
        <p:nvSpPr>
          <p:cNvPr id="23" name="Rectangle 22"/>
          <p:cNvSpPr/>
          <p:nvPr/>
        </p:nvSpPr>
        <p:spPr>
          <a:xfrm>
            <a:off x="1417063" y="879029"/>
            <a:ext cx="5982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Courier New" panose="02070309020205020404" pitchFamily="49" charset="0"/>
                <a:cs typeface="Courier New" panose="02070309020205020404" pitchFamily="49" charset="0"/>
              </a:rPr>
              <a:t>- -</a:t>
            </a:r>
            <a:endParaRPr lang="en-US" dirty="0"/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928" y="2940419"/>
            <a:ext cx="4883319" cy="363353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44966" y="13381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23747" y="2698595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85259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3 Fig</a:t>
            </a:r>
          </a:p>
        </p:txBody>
      </p:sp>
    </p:spTree>
    <p:extLst>
      <p:ext uri="{BB962C8B-B14F-4D97-AF65-F5344CB8AC3E}">
        <p14:creationId xmlns:p14="http://schemas.microsoft.com/office/powerpoint/2010/main" val="28144522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7</TotalTime>
  <Words>425</Words>
  <Application>Microsoft Office PowerPoint</Application>
  <PresentationFormat>Letter Paper (8.5x11 in)</PresentationFormat>
  <Paragraphs>93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mmers, Joshua (NIH/NIA/IRP) [E]</dc:creator>
  <cp:lastModifiedBy>Sommers, Joshua (NIH/NIA/IRP) [E]</cp:lastModifiedBy>
  <cp:revision>30</cp:revision>
  <dcterms:created xsi:type="dcterms:W3CDTF">2017-04-20T16:52:01Z</dcterms:created>
  <dcterms:modified xsi:type="dcterms:W3CDTF">2018-12-20T22:39:45Z</dcterms:modified>
</cp:coreProperties>
</file>